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snapToObjects="1">
      <p:cViewPr varScale="1">
        <p:scale>
          <a:sx n="128" d="100"/>
          <a:sy n="128" d="100"/>
        </p:scale>
        <p:origin x="48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326E60-5CAB-0D4F-9832-C60D3337B1C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B37482F-3BBE-7246-A89B-C4E86CA1A95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9B3AD81-DED5-6A41-B5EA-C7B23BBB9618}"/>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CF6B94E8-E494-B64C-B60F-774A20D4B9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524A57-B3C2-C546-88D5-B8567C3A29B4}"/>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7319330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227A9F-4896-D242-AB9F-E6120A05FD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E3EB960-A808-DA47-BB09-782BADBDCDB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89E881-7BA4-3746-947C-94CEEA6F2B1C}"/>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6EE454E2-6298-044F-9DAE-44CAAC0040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CCD1289-15F1-3545-B5D4-E09ACAEC83FD}"/>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42472904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F627E69-0A26-EE4B-80CD-3297D5B3F5A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A9E584E-C618-CA4C-9437-C6634F4B48C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B698AE-97D9-854F-8858-6DF7ADE86B6F}"/>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4437143B-1776-2B46-BB2A-671C68B7CD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9010AA-FB7A-D346-A5FA-047E7F889961}"/>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489170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74E9B9-1295-1746-9FCD-C23C4495DC1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CD58457-2689-4F47-8B36-F975C6E4D84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04B4CA3-6527-7848-87DD-D18EF8364B8F}"/>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4B3F6AE6-2A3D-5043-8060-50A950F074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016FA2-C4BC-B342-8D5C-FFE222366826}"/>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7946710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4DD6F-8EDA-8042-AB96-828D7AC6CD3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33579D5-EB8D-4C45-878C-760E97FB690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B08ECE0-C019-8246-A182-5A07AA607CA6}"/>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D0286E5E-60A6-124C-88A3-2A057E406F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F7E4C3-ACE0-354F-88A8-A300100C0A46}"/>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2116434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D1B5EF-D02F-2C4A-B4CE-D4FD3C00B23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A1787A2-AE6C-504E-ADC0-4B3066B553F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DE0566C-D1ED-6E44-800A-0866E67C602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9B8A3FD-64AE-5A44-82F6-CA0DA91F51D4}"/>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B95468D5-0944-7F43-8C54-E7D5D50C6D4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AE007E4-8EC8-784B-A72A-6D1FA3C2B044}"/>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41494005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BC7E22-C2D8-8B49-AE4C-99B0AEE4489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9899BED-BA33-E346-B890-6D2EF1066F0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C971F25-DBC7-5E4B-AA86-1C6048C5536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2B03575-416E-884E-A6DE-9F73AF25E4E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BD373D1-C5BD-A340-85E4-26F21F7295D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2CAC8E6-C8D0-F948-9DDF-A28EC427D4C3}"/>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8" name="Footer Placeholder 7">
            <a:extLst>
              <a:ext uri="{FF2B5EF4-FFF2-40B4-BE49-F238E27FC236}">
                <a16:creationId xmlns:a16="http://schemas.microsoft.com/office/drawing/2014/main" id="{F05CB6F7-AA69-6741-BA8F-D43D612320B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747E9CE-8241-CF44-AB5E-B226BAB4FFE1}"/>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29123136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9C3334-87A8-7044-A7BB-ABACB2E587D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DF95BA3-0909-C047-B996-7F590EEA76A4}"/>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4" name="Footer Placeholder 3">
            <a:extLst>
              <a:ext uri="{FF2B5EF4-FFF2-40B4-BE49-F238E27FC236}">
                <a16:creationId xmlns:a16="http://schemas.microsoft.com/office/drawing/2014/main" id="{D46A5869-4578-6847-830A-DCDA04573C0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802F8E7-C7D2-F540-8616-349CCD46A6AB}"/>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9489859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6DF2A93-005A-9046-87C8-AE2A18D1E602}"/>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3" name="Footer Placeholder 2">
            <a:extLst>
              <a:ext uri="{FF2B5EF4-FFF2-40B4-BE49-F238E27FC236}">
                <a16:creationId xmlns:a16="http://schemas.microsoft.com/office/drawing/2014/main" id="{358916BD-5718-1942-910F-7721B3E7612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DE4A17F-5CB0-044C-AD94-ADFDC163B68A}"/>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9225505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133C1C-795D-1142-8A23-3531C8B37CE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BF17CC3-AC98-3D4B-BB85-3CEACE3801D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3BC4DD-AD10-4B45-90B5-10D76B13288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44CB674-A5F5-774D-8AEB-754B12FB6E4B}"/>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B056B79E-EBD0-934C-AA19-A01555FC65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B28945-64C6-614C-B5E2-A6F863A07A5B}"/>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22861620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4CAC08-01C0-D34E-90DE-D62ABD5F29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5DF0F56-91A8-9344-BE6C-51D5C708DA5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A060D65-935E-2849-8065-68A029CF75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E2EA5F0-9F57-3B43-B1F0-3A16BAF02222}"/>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3C15758C-BC69-B34E-B00B-5844C874611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E8AC13C-3EE9-9242-9A44-5DB75A4CD10F}"/>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6227112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17BB337-A069-BA42-9D4B-04B1D5CB92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0B6F025-FD78-1F42-AEC2-38DCF1EE8A4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3A7C90-DD23-7F4C-9E12-98E0D073DCA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7A87A7A9-E4A8-6F44-AB7A-6B3F41CCC37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70DF944-A46F-0441-BE12-2370D1B98DE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3F5DCA-6D21-8740-9F65-58CEFC1F120F}" type="slidenum">
              <a:rPr lang="en-US" smtClean="0"/>
              <a:t>‹#›</a:t>
            </a:fld>
            <a:endParaRPr lang="en-US"/>
          </a:p>
        </p:txBody>
      </p:sp>
    </p:spTree>
    <p:extLst>
      <p:ext uri="{BB962C8B-B14F-4D97-AF65-F5344CB8AC3E}">
        <p14:creationId xmlns:p14="http://schemas.microsoft.com/office/powerpoint/2010/main" val="3797527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121E2CA-F7F9-AE43-BF07-3F5FF7122386}"/>
              </a:ext>
            </a:extLst>
          </p:cNvPr>
          <p:cNvPicPr>
            <a:picLocks noChangeAspect="1"/>
          </p:cNvPicPr>
          <p:nvPr/>
        </p:nvPicPr>
        <p:blipFill>
          <a:blip r:embed="rId2"/>
          <a:stretch>
            <a:fillRect/>
          </a:stretch>
        </p:blipFill>
        <p:spPr>
          <a:xfrm>
            <a:off x="1368777" y="74070"/>
            <a:ext cx="9060723" cy="5382513"/>
          </a:xfrm>
          <a:prstGeom prst="rect">
            <a:avLst/>
          </a:prstGeom>
        </p:spPr>
      </p:pic>
      <p:sp>
        <p:nvSpPr>
          <p:cNvPr id="3" name="TextBox 2">
            <a:extLst>
              <a:ext uri="{FF2B5EF4-FFF2-40B4-BE49-F238E27FC236}">
                <a16:creationId xmlns:a16="http://schemas.microsoft.com/office/drawing/2014/main" id="{004A9038-7061-3D49-97A2-4A561A74107F}"/>
              </a:ext>
            </a:extLst>
          </p:cNvPr>
          <p:cNvSpPr txBox="1"/>
          <p:nvPr/>
        </p:nvSpPr>
        <p:spPr>
          <a:xfrm>
            <a:off x="1368777" y="5542578"/>
            <a:ext cx="9060723" cy="1092607"/>
          </a:xfrm>
          <a:prstGeom prst="rect">
            <a:avLst/>
          </a:prstGeom>
          <a:noFill/>
        </p:spPr>
        <p:txBody>
          <a:bodyPr wrap="square" rtlCol="0">
            <a:spAutoFit/>
          </a:bodyPr>
          <a:lstStyle/>
          <a:p>
            <a:pPr lvl="0" algn="just">
              <a:defRPr/>
            </a:pPr>
            <a:r>
              <a:rPr lang="en-US" sz="1300" b="1" dirty="0">
                <a:latin typeface="Arial" panose="020B0604020202020204" pitchFamily="34" charset="0"/>
                <a:cs typeface="Arial" panose="020B0604020202020204" pitchFamily="34" charset="0"/>
              </a:rPr>
              <a:t>Supplementary Figure 1.</a:t>
            </a:r>
            <a:r>
              <a:rPr lang="en-US" sz="1300" dirty="0">
                <a:latin typeface="Arial" panose="020B0604020202020204" pitchFamily="34" charset="0"/>
                <a:cs typeface="Arial" panose="020B0604020202020204" pitchFamily="34" charset="0"/>
              </a:rPr>
              <a:t> Scatterplots of DNAm fitness biomarker models versus true fitness values in training data. Pink indicates females, and blue indicates males. Each panel corresponds to the training performance of one DNAm biomarker model built with chronological age displayed with Pearson correlation and p-values. (</a:t>
            </a:r>
            <a:r>
              <a:rPr lang="en-US" sz="1300" b="1" dirty="0">
                <a:latin typeface="Arial" panose="020B0604020202020204" pitchFamily="34" charset="0"/>
                <a:cs typeface="Arial" panose="020B0604020202020204" pitchFamily="34" charset="0"/>
              </a:rPr>
              <a:t>A)</a:t>
            </a:r>
            <a:r>
              <a:rPr lang="en-US" sz="1300" dirty="0">
                <a:latin typeface="Arial" panose="020B0604020202020204" pitchFamily="34" charset="0"/>
                <a:cs typeface="Arial" panose="020B0604020202020204" pitchFamily="34" charset="0"/>
              </a:rPr>
              <a:t> DNAmGaitspeed, (</a:t>
            </a:r>
            <a:r>
              <a:rPr lang="en-US" sz="1300" b="1" dirty="0">
                <a:latin typeface="Arial" panose="020B0604020202020204" pitchFamily="34" charset="0"/>
                <a:cs typeface="Arial" panose="020B0604020202020204" pitchFamily="34" charset="0"/>
              </a:rPr>
              <a:t>B)</a:t>
            </a:r>
            <a:r>
              <a:rPr lang="en-US" sz="1300" dirty="0">
                <a:latin typeface="Arial" panose="020B0604020202020204" pitchFamily="34" charset="0"/>
                <a:cs typeface="Arial" panose="020B0604020202020204" pitchFamily="34" charset="0"/>
              </a:rPr>
              <a:t> DNAmGripmax, (</a:t>
            </a:r>
            <a:r>
              <a:rPr lang="en-US" sz="1300" b="1" dirty="0">
                <a:latin typeface="Arial" panose="020B0604020202020204" pitchFamily="34" charset="0"/>
                <a:cs typeface="Arial" panose="020B0604020202020204" pitchFamily="34" charset="0"/>
              </a:rPr>
              <a:t>C)</a:t>
            </a:r>
            <a:r>
              <a:rPr lang="en-US" sz="1300" dirty="0">
                <a:latin typeface="Arial" panose="020B0604020202020204" pitchFamily="34" charset="0"/>
                <a:cs typeface="Arial" panose="020B0604020202020204" pitchFamily="34" charset="0"/>
              </a:rPr>
              <a:t> DNAmFEV1, and (</a:t>
            </a:r>
            <a:r>
              <a:rPr lang="en-US" sz="1300" b="1" dirty="0">
                <a:latin typeface="Arial" panose="020B0604020202020204" pitchFamily="34" charset="0"/>
                <a:cs typeface="Arial" panose="020B0604020202020204" pitchFamily="34" charset="0"/>
              </a:rPr>
              <a:t>D)</a:t>
            </a:r>
            <a:r>
              <a:rPr lang="en-US" sz="1300" dirty="0">
                <a:latin typeface="Arial" panose="020B0604020202020204" pitchFamily="34" charset="0"/>
                <a:cs typeface="Arial" panose="020B0604020202020204" pitchFamily="34" charset="0"/>
              </a:rPr>
              <a:t> DNAmVO2max. (</a:t>
            </a:r>
            <a:r>
              <a:rPr lang="en-US" sz="1300" b="1" dirty="0">
                <a:latin typeface="Arial" panose="020B0604020202020204" pitchFamily="34" charset="0"/>
                <a:cs typeface="Arial" panose="020B0604020202020204" pitchFamily="34" charset="0"/>
              </a:rPr>
              <a:t>A-C)</a:t>
            </a:r>
            <a:r>
              <a:rPr lang="en-US" sz="1300" dirty="0">
                <a:latin typeface="Arial" panose="020B0604020202020204" pitchFamily="34" charset="0"/>
                <a:cs typeface="Arial" panose="020B0604020202020204" pitchFamily="34" charset="0"/>
              </a:rPr>
              <a:t> (DNAmGaitspeed, DNAmGripmax, and DNAmFEV1) were built in each sex separately while (</a:t>
            </a:r>
            <a:r>
              <a:rPr lang="en-US" sz="1300" b="1" dirty="0">
                <a:latin typeface="Arial" panose="020B0604020202020204" pitchFamily="34" charset="0"/>
                <a:cs typeface="Arial" panose="020B0604020202020204" pitchFamily="34" charset="0"/>
              </a:rPr>
              <a:t>D)</a:t>
            </a:r>
            <a:r>
              <a:rPr lang="en-US" sz="1300" dirty="0">
                <a:latin typeface="Arial" panose="020B0604020202020204" pitchFamily="34" charset="0"/>
                <a:cs typeface="Arial" panose="020B0604020202020204" pitchFamily="34" charset="0"/>
              </a:rPr>
              <a:t> (DNAmVO2max) was built in both sexes jointly. </a:t>
            </a:r>
          </a:p>
        </p:txBody>
      </p:sp>
    </p:spTree>
    <p:extLst>
      <p:ext uri="{BB962C8B-B14F-4D97-AF65-F5344CB8AC3E}">
        <p14:creationId xmlns:p14="http://schemas.microsoft.com/office/powerpoint/2010/main" val="280299300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02</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risten McGreevy</dc:creator>
  <cp:lastModifiedBy>Kristen McGreevy</cp:lastModifiedBy>
  <cp:revision>1</cp:revision>
  <dcterms:created xsi:type="dcterms:W3CDTF">2022-03-08T00:08:06Z</dcterms:created>
  <dcterms:modified xsi:type="dcterms:W3CDTF">2022-03-08T00:08:36Z</dcterms:modified>
</cp:coreProperties>
</file>